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292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3E694-EAA3-4690-A251-D36257496FDC}" type="datetimeFigureOut">
              <a:rPr lang="en-US" smtClean="0"/>
              <a:t>5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A375-8581-4385-AC0A-1E89E33F3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44485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3E694-EAA3-4690-A251-D36257496FDC}" type="datetimeFigureOut">
              <a:rPr lang="en-US" smtClean="0"/>
              <a:t>5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A375-8581-4385-AC0A-1E89E33F3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9147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3E694-EAA3-4690-A251-D36257496FDC}" type="datetimeFigureOut">
              <a:rPr lang="en-US" smtClean="0"/>
              <a:t>5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A375-8581-4385-AC0A-1E89E33F3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25746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3E694-EAA3-4690-A251-D36257496FDC}" type="datetimeFigureOut">
              <a:rPr lang="en-US" smtClean="0"/>
              <a:t>5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A375-8581-4385-AC0A-1E89E33F3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0666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3E694-EAA3-4690-A251-D36257496FDC}" type="datetimeFigureOut">
              <a:rPr lang="en-US" smtClean="0"/>
              <a:t>5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A375-8581-4385-AC0A-1E89E33F3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72255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3E694-EAA3-4690-A251-D36257496FDC}" type="datetimeFigureOut">
              <a:rPr lang="en-US" smtClean="0"/>
              <a:t>5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A375-8581-4385-AC0A-1E89E33F3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74735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3E694-EAA3-4690-A251-D36257496FDC}" type="datetimeFigureOut">
              <a:rPr lang="en-US" smtClean="0"/>
              <a:t>5/12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A375-8581-4385-AC0A-1E89E33F3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16174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3E694-EAA3-4690-A251-D36257496FDC}" type="datetimeFigureOut">
              <a:rPr lang="en-US" smtClean="0"/>
              <a:t>5/12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A375-8581-4385-AC0A-1E89E33F3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23458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3E694-EAA3-4690-A251-D36257496FDC}" type="datetimeFigureOut">
              <a:rPr lang="en-US" smtClean="0"/>
              <a:t>5/12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A375-8581-4385-AC0A-1E89E33F3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5896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3E694-EAA3-4690-A251-D36257496FDC}" type="datetimeFigureOut">
              <a:rPr lang="en-US" smtClean="0"/>
              <a:t>5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A375-8581-4385-AC0A-1E89E33F3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498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3E694-EAA3-4690-A251-D36257496FDC}" type="datetimeFigureOut">
              <a:rPr lang="en-US" smtClean="0"/>
              <a:t>5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A375-8581-4385-AC0A-1E89E33F3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11977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23E694-EAA3-4690-A251-D36257496FDC}" type="datetimeFigureOut">
              <a:rPr lang="en-US" smtClean="0"/>
              <a:t>5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A1A375-8581-4385-AC0A-1E89E33F3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89087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E9FDD428-6A87-43DE-88BD-F1807954C19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265" t="13746" r="7504" b="75529"/>
          <a:stretch/>
        </p:blipFill>
        <p:spPr>
          <a:xfrm>
            <a:off x="331534" y="627188"/>
            <a:ext cx="6099732" cy="155835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00CD6F86-982C-4AB1-8B3E-E8AA4378F788}"/>
              </a:ext>
            </a:extLst>
          </p:cNvPr>
          <p:cNvSpPr/>
          <p:nvPr/>
        </p:nvSpPr>
        <p:spPr>
          <a:xfrm>
            <a:off x="278516" y="676889"/>
            <a:ext cx="6378580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/>
              <a:t>Q05117</a:t>
            </a:r>
            <a:r>
              <a:rPr lang="en-US" sz="1100" dirty="0"/>
              <a:t> </a:t>
            </a:r>
            <a:r>
              <a:rPr lang="en-US" sz="1100" b="1" dirty="0"/>
              <a:t>Tartrate-resistant acid phosphatase type 5: 42% Coverage (Osteoclast)</a:t>
            </a:r>
            <a:endParaRPr lang="en-US" sz="1100" dirty="0"/>
          </a:p>
          <a:p>
            <a:pPr algn="just"/>
            <a:r>
              <a:rPr lang="en-US" sz="1100" dirty="0"/>
              <a:t>MDSWVVLLGLQIIWLPLLTHGTAPTPTLR</a:t>
            </a:r>
            <a:r>
              <a:rPr lang="en-US" sz="1100" dirty="0">
                <a:solidFill>
                  <a:srgbClr val="00B050"/>
                </a:solidFill>
              </a:rPr>
              <a:t>FVAVGDWGGVPNAPFHTAR</a:t>
            </a:r>
            <a:r>
              <a:rPr lang="en-US" sz="1100" dirty="0"/>
              <a:t>EMANAKEIAR</a:t>
            </a:r>
            <a:r>
              <a:rPr lang="en-US" sz="1100" dirty="0">
                <a:solidFill>
                  <a:srgbClr val="00B050"/>
                </a:solidFill>
              </a:rPr>
              <a:t>TVQTMGADFIMSLGDNFYFTGVHDASDKRFQETFEDVFSDR</a:t>
            </a:r>
            <a:r>
              <a:rPr lang="en-US" sz="1100" dirty="0"/>
              <a:t>ALRNIPWYVLAGNHDHLGNVAQIAYSKISKR</a:t>
            </a:r>
            <a:r>
              <a:rPr lang="en-US" sz="1100" dirty="0">
                <a:solidFill>
                  <a:srgbClr val="00B050"/>
                </a:solidFill>
              </a:rPr>
              <a:t>WNFPSPYYR</a:t>
            </a:r>
            <a:r>
              <a:rPr lang="en-US" sz="1100" dirty="0"/>
              <a:t>LRFKIPRTNITVAIFMLDTVMLCGNSDDFASQQPKMPRDLGVAR</a:t>
            </a:r>
            <a:r>
              <a:rPr lang="en-US" sz="1100" dirty="0">
                <a:solidFill>
                  <a:srgbClr val="00B050"/>
                </a:solidFill>
              </a:rPr>
              <a:t>TQLSWLKKQLAAAKEDYVLVAGHYPIWSIAEHGPTR</a:t>
            </a:r>
            <a:r>
              <a:rPr lang="en-US" sz="1100" dirty="0"/>
              <a:t>CLVKNLRPLLATYGVTAYLCGHDHNLQYLQDENGVGYVLSGAGNFMDPSVRHQRKVPNGYLR</a:t>
            </a:r>
            <a:r>
              <a:rPr lang="en-US" sz="1100" dirty="0">
                <a:solidFill>
                  <a:srgbClr val="00B050"/>
                </a:solidFill>
              </a:rPr>
              <a:t>FHYGSEDSLGGFTHVEISPK EMTIIYVEASGK</a:t>
            </a:r>
            <a:r>
              <a:rPr lang="en-US" sz="1100" dirty="0"/>
              <a:t>SLFKTSLPRRPRP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40158919-1A76-4F69-8A7A-2C35B958CD2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19" t="51384" r="7577" b="46028"/>
          <a:stretch/>
        </p:blipFill>
        <p:spPr>
          <a:xfrm>
            <a:off x="331534" y="2112814"/>
            <a:ext cx="6099733" cy="155835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92EADBD5-1476-413A-A3C4-FA2ACCC60650}"/>
              </a:ext>
            </a:extLst>
          </p:cNvPr>
          <p:cNvSpPr/>
          <p:nvPr/>
        </p:nvSpPr>
        <p:spPr>
          <a:xfrm>
            <a:off x="278516" y="2162515"/>
            <a:ext cx="6378580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/>
              <a:t>P07214 SPARC: 51% Coverage (Osteoblast)</a:t>
            </a:r>
            <a:endParaRPr lang="en-US" sz="1100" dirty="0"/>
          </a:p>
          <a:p>
            <a:pPr algn="just"/>
            <a:r>
              <a:rPr lang="en-US" sz="1100" dirty="0"/>
              <a:t>MRAWIFFLLCLAGRALAAPQQTEVAEEIVEEETVVEETGVPVGANPVQVEMGEFEDGAEETVEEVVADNPCQNHHCK</a:t>
            </a:r>
            <a:r>
              <a:rPr lang="en-US" sz="1100" dirty="0">
                <a:solidFill>
                  <a:srgbClr val="00B050"/>
                </a:solidFill>
              </a:rPr>
              <a:t>HGKVCELDESNTPMCVCQDPTSCPAPIGEFEKV</a:t>
            </a:r>
            <a:r>
              <a:rPr lang="en-US" sz="1100" dirty="0"/>
              <a:t>CSNDNKTFDSSCHFFATKCTLEGTKK</a:t>
            </a:r>
            <a:r>
              <a:rPr lang="en-US" sz="1100" dirty="0">
                <a:solidFill>
                  <a:srgbClr val="00B050"/>
                </a:solidFill>
              </a:rPr>
              <a:t>GHKLHLDYIGPCKYIAPCLDSELTEFPLR</a:t>
            </a:r>
            <a:r>
              <a:rPr lang="en-US" sz="1100" dirty="0"/>
              <a:t>MRDWLK</a:t>
            </a:r>
            <a:r>
              <a:rPr lang="en-US" sz="1100" dirty="0">
                <a:solidFill>
                  <a:srgbClr val="00B050"/>
                </a:solidFill>
              </a:rPr>
              <a:t>NVLVTLYERDEGNNLLTEKQK</a:t>
            </a:r>
            <a:r>
              <a:rPr lang="en-US" sz="1100" dirty="0"/>
              <a:t>LRVKK</a:t>
            </a:r>
            <a:r>
              <a:rPr lang="en-US" sz="1100" dirty="0">
                <a:solidFill>
                  <a:srgbClr val="00B050"/>
                </a:solidFill>
              </a:rPr>
              <a:t>IHENEKRLEAGDHPVELLARDFEK</a:t>
            </a:r>
            <a:r>
              <a:rPr lang="en-US" sz="1100" dirty="0"/>
              <a:t>NYNMYIFPVHWQFGQLDQHPIDGYLSHTELAPLR</a:t>
            </a:r>
            <a:r>
              <a:rPr lang="en-US" sz="1100" dirty="0">
                <a:solidFill>
                  <a:srgbClr val="00B050"/>
                </a:solidFill>
              </a:rPr>
              <a:t>APLIPMEHCTTRFFETCDLDNDKYIALEEWAGCFGIK EQDINKDLVI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E8F057C0-4636-4E3C-B12C-726C64B242D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1319" t="36063" r="7181" b="61315"/>
          <a:stretch/>
        </p:blipFill>
        <p:spPr>
          <a:xfrm>
            <a:off x="331534" y="3459940"/>
            <a:ext cx="6179120" cy="136570"/>
          </a:xfrm>
          <a:prstGeom prst="rect">
            <a:avLst/>
          </a:prstGeom>
        </p:spPr>
      </p:pic>
      <p:sp>
        <p:nvSpPr>
          <p:cNvPr id="13" name="Rectangle 12">
            <a:extLst>
              <a:ext uri="{FF2B5EF4-FFF2-40B4-BE49-F238E27FC236}">
                <a16:creationId xmlns:a16="http://schemas.microsoft.com/office/drawing/2014/main" id="{180EF4DA-C924-4251-8924-759F6955DDEC}"/>
              </a:ext>
            </a:extLst>
          </p:cNvPr>
          <p:cNvSpPr/>
          <p:nvPr/>
        </p:nvSpPr>
        <p:spPr>
          <a:xfrm>
            <a:off x="278516" y="3523829"/>
            <a:ext cx="6378580" cy="19543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/>
              <a:t>P70669 Phosphate-regulating neutral endopeptidase PHEX: 39% Coverage (Osteocyte)</a:t>
            </a:r>
            <a:endParaRPr lang="en-US" sz="1100" dirty="0"/>
          </a:p>
          <a:p>
            <a:pPr algn="just"/>
            <a:r>
              <a:rPr lang="en-US" sz="1100" dirty="0"/>
              <a:t>MEAETGSTMETGKGTNRGIRIALALFIGGTLVLGTLLFLVSQGLLSFQAK</a:t>
            </a:r>
            <a:r>
              <a:rPr lang="en-US" sz="1100" dirty="0">
                <a:solidFill>
                  <a:srgbClr val="00B050"/>
                </a:solidFill>
              </a:rPr>
              <a:t>QEYCLKPECIEAAAAIMSK</a:t>
            </a:r>
            <a:r>
              <a:rPr lang="en-US" sz="1100" dirty="0"/>
              <a:t>VNLSVDPCENFFRFACDGWISNNPIPEDMPSYGVYPWLRHNVDLKLKALLEKSVSRRRDTEAVQKAK</a:t>
            </a:r>
            <a:r>
              <a:rPr lang="en-US" sz="1100" dirty="0">
                <a:solidFill>
                  <a:srgbClr val="00B050"/>
                </a:solidFill>
              </a:rPr>
              <a:t>ILYSSCMNEKAIEKADAKPLLHILR</a:t>
            </a:r>
            <a:r>
              <a:rPr lang="en-US" sz="1100" dirty="0"/>
              <a:t>HSPFR</a:t>
            </a:r>
            <a:r>
              <a:rPr lang="en-US" sz="1100" dirty="0">
                <a:solidFill>
                  <a:srgbClr val="00B050"/>
                </a:solidFill>
              </a:rPr>
              <a:t>WPVLEANIGPEGVWSERKFSLLQTLATFRGQYSNSVFIRLYVSPDDKASNEHILKLDQATLSLAVRE</a:t>
            </a:r>
            <a:r>
              <a:rPr lang="en-US" sz="1100" dirty="0"/>
              <a:t>DFLDNTTEAKSYRDALYKFMVDTAVLLGANSSRAEHDMKSVLRLEIKIAEIMIPHENRTSEAMYNKMNISELSAMIPQFDWLGYIKKVIDTRLYPHLKDIGPSENVVVRVPQYFKDLFRILGAERKKTIANYLVWRMVYSRIPNLSRRFQYRWLEFSR</a:t>
            </a:r>
            <a:r>
              <a:rPr lang="en-US" sz="1100" dirty="0">
                <a:solidFill>
                  <a:srgbClr val="00B050"/>
                </a:solidFill>
              </a:rPr>
              <a:t>VIQGTTTLLPQWDKCVNFIESALPYVVGKMFVNVHFQEDKKEMMEELIEGVRWAFIDMLEK</a:t>
            </a:r>
            <a:r>
              <a:rPr lang="en-US" sz="1100" dirty="0"/>
              <a:t>ENEWMDAGTKRKAQEKARAVLAKVGYPEFIMNDTYVNEDLKAIK</a:t>
            </a:r>
            <a:r>
              <a:rPr lang="en-US" sz="1100" dirty="0">
                <a:solidFill>
                  <a:srgbClr val="00B050"/>
                </a:solidFill>
              </a:rPr>
              <a:t>FSESDYFGNVLQTRKYLAQSDFFWLR</a:t>
            </a:r>
            <a:r>
              <a:rPr lang="en-US" sz="1100" dirty="0"/>
              <a:t>KAVPK</a:t>
            </a:r>
            <a:r>
              <a:rPr lang="en-US" sz="1100" dirty="0">
                <a:solidFill>
                  <a:srgbClr val="00B050"/>
                </a:solidFill>
              </a:rPr>
              <a:t>TEWFTNPTTVNAFYSASTNQIR</a:t>
            </a:r>
            <a:r>
              <a:rPr lang="en-US" sz="1100" dirty="0"/>
              <a:t>FPAGELQKPFFWGTEYPR</a:t>
            </a:r>
            <a:r>
              <a:rPr lang="en-US" sz="1100" dirty="0">
                <a:solidFill>
                  <a:srgbClr val="00B050"/>
                </a:solidFill>
              </a:rPr>
              <a:t>SLSYGAIGVIVGHEFTHGFDNNGR</a:t>
            </a:r>
            <a:r>
              <a:rPr lang="en-US" sz="1100" dirty="0"/>
              <a:t>KYDKNGNLDPWWSVESEEKFKEKTK</a:t>
            </a:r>
            <a:r>
              <a:rPr lang="en-US" sz="1100" dirty="0">
                <a:solidFill>
                  <a:srgbClr val="00B050"/>
                </a:solidFill>
              </a:rPr>
              <a:t>CMINQYSNYYWK</a:t>
            </a:r>
            <a:r>
              <a:rPr lang="en-US" sz="1100" dirty="0"/>
              <a:t>KAGLNVKGKR</a:t>
            </a:r>
            <a:r>
              <a:rPr lang="en-US" sz="1100" dirty="0">
                <a:solidFill>
                  <a:srgbClr val="00B050"/>
                </a:solidFill>
              </a:rPr>
              <a:t>TLGENIADNGGLR</a:t>
            </a:r>
            <a:r>
              <a:rPr lang="en-US" sz="1100" dirty="0"/>
              <a:t>EAFRAYRKWINDRRQGVEEPLLPGITFTNNQLFFLSYAHVRCNSYRPEAARE</a:t>
            </a:r>
            <a:r>
              <a:rPr lang="en-US" sz="1100" dirty="0">
                <a:solidFill>
                  <a:srgbClr val="00B050"/>
                </a:solidFill>
              </a:rPr>
              <a:t>QVQIGAHSPPQFRVNGAISNFEEFQK</a:t>
            </a:r>
            <a:r>
              <a:rPr lang="en-US" sz="1100" dirty="0"/>
              <a:t>AFNCPRNSTMNRGADSCRLW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1B1C681-10D8-4AF5-9F24-FF2AA53EDFDA}"/>
              </a:ext>
            </a:extLst>
          </p:cNvPr>
          <p:cNvSpPr txBox="1"/>
          <p:nvPr/>
        </p:nvSpPr>
        <p:spPr>
          <a:xfrm>
            <a:off x="4573309" y="8774668"/>
            <a:ext cx="25870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Figure 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8DB277A-5F21-415B-894B-A8D0463C0542}"/>
              </a:ext>
            </a:extLst>
          </p:cNvPr>
          <p:cNvSpPr txBox="1"/>
          <p:nvPr/>
        </p:nvSpPr>
        <p:spPr>
          <a:xfrm>
            <a:off x="280780" y="394768"/>
            <a:ext cx="5531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00"/>
            </a:lvl1pPr>
          </a:lstStyle>
          <a:p>
            <a:r>
              <a:rPr lang="en-US" dirty="0"/>
              <a:t>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5CB55B8-43AC-445B-9C98-E0B714546B65}"/>
              </a:ext>
            </a:extLst>
          </p:cNvPr>
          <p:cNvSpPr txBox="1"/>
          <p:nvPr/>
        </p:nvSpPr>
        <p:spPr>
          <a:xfrm>
            <a:off x="5935776" y="394768"/>
            <a:ext cx="5531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00"/>
            </a:lvl1pPr>
          </a:lstStyle>
          <a:p>
            <a:r>
              <a:rPr lang="en-US" dirty="0"/>
              <a:t>327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505A8BF-8D0A-4218-A9CB-934663E15A21}"/>
              </a:ext>
            </a:extLst>
          </p:cNvPr>
          <p:cNvSpPr txBox="1"/>
          <p:nvPr/>
        </p:nvSpPr>
        <p:spPr>
          <a:xfrm>
            <a:off x="278516" y="1911171"/>
            <a:ext cx="6342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EB29814-599E-4FF2-BEE8-8A0B6E17C0DC}"/>
              </a:ext>
            </a:extLst>
          </p:cNvPr>
          <p:cNvSpPr txBox="1"/>
          <p:nvPr/>
        </p:nvSpPr>
        <p:spPr>
          <a:xfrm>
            <a:off x="278516" y="3171765"/>
            <a:ext cx="6342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6A46FD8-44C2-4534-B783-56E1670780CB}"/>
              </a:ext>
            </a:extLst>
          </p:cNvPr>
          <p:cNvSpPr txBox="1"/>
          <p:nvPr/>
        </p:nvSpPr>
        <p:spPr>
          <a:xfrm>
            <a:off x="5932166" y="1880394"/>
            <a:ext cx="6342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30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6522569-8757-4EEC-A2D8-E97725FE2159}"/>
              </a:ext>
            </a:extLst>
          </p:cNvPr>
          <p:cNvSpPr txBox="1"/>
          <p:nvPr/>
        </p:nvSpPr>
        <p:spPr>
          <a:xfrm>
            <a:off x="5932166" y="3171765"/>
            <a:ext cx="6342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749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4FFBD953-1CBF-4196-8E84-66EE7C4DA6E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22" t="13855" r="2222" b="69791"/>
          <a:stretch/>
        </p:blipFill>
        <p:spPr>
          <a:xfrm>
            <a:off x="331534" y="5803463"/>
            <a:ext cx="6099732" cy="205158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055AD46A-53B4-435E-859F-75C2BCC4C8EC}"/>
              </a:ext>
            </a:extLst>
          </p:cNvPr>
          <p:cNvSpPr txBox="1"/>
          <p:nvPr/>
        </p:nvSpPr>
        <p:spPr>
          <a:xfrm>
            <a:off x="278516" y="5571043"/>
            <a:ext cx="6342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901C1BD-62F1-4B10-9271-C43B1937980C}"/>
              </a:ext>
            </a:extLst>
          </p:cNvPr>
          <p:cNvSpPr txBox="1"/>
          <p:nvPr/>
        </p:nvSpPr>
        <p:spPr>
          <a:xfrm>
            <a:off x="5932166" y="5571043"/>
            <a:ext cx="6342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211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C01435A3-DCE4-41F0-BBFF-6114814D6ADA}"/>
              </a:ext>
            </a:extLst>
          </p:cNvPr>
          <p:cNvSpPr/>
          <p:nvPr/>
        </p:nvSpPr>
        <p:spPr>
          <a:xfrm>
            <a:off x="278516" y="5902487"/>
            <a:ext cx="6378580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/>
              <a:t>Q99P68 Sclerostin SOST: 14% Coverage (Osteocyte)</a:t>
            </a:r>
          </a:p>
          <a:p>
            <a:pPr algn="just"/>
            <a:r>
              <a:rPr lang="en-US" altLang="en-US" sz="1100" dirty="0"/>
              <a:t>MQPSLAPCLICLLVHAAFCAVEGQGWQAFRNDATEVIPGLGEYPEPPPENNQTMNRAENGGRPPHHPYDAKDVSEYSCRELHYTRFLTDGPCR</a:t>
            </a:r>
            <a:r>
              <a:rPr lang="en-US" altLang="en-US" sz="1100" dirty="0">
                <a:solidFill>
                  <a:srgbClr val="00B050"/>
                </a:solidFill>
              </a:rPr>
              <a:t>SAKPVTELVCSGQCGPAR</a:t>
            </a:r>
            <a:r>
              <a:rPr lang="en-US" altLang="en-US" sz="1100" dirty="0"/>
              <a:t>LLPNAIGRVKWWRPNGPDFRCIPDRYRAQR</a:t>
            </a:r>
            <a:r>
              <a:rPr lang="en-US" altLang="en-US" sz="1100" dirty="0">
                <a:solidFill>
                  <a:srgbClr val="00B050"/>
                </a:solidFill>
              </a:rPr>
              <a:t>VQLLCPGGAAPR</a:t>
            </a:r>
            <a:r>
              <a:rPr lang="en-US" altLang="en-US" sz="1100" dirty="0"/>
              <a:t>SRKVRLVASCKCKRLTRFHNQSELKDFGPETARPQKGRKPRPGARGAKANQAELENAY </a:t>
            </a:r>
          </a:p>
          <a:p>
            <a:endParaRPr lang="en-US" sz="1100" dirty="0"/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FD863491-DED5-48C4-99FF-748AF3CB6F64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00" t="62232" r="2534" b="34415"/>
          <a:stretch/>
        </p:blipFill>
        <p:spPr>
          <a:xfrm>
            <a:off x="323914" y="7199912"/>
            <a:ext cx="6152750" cy="130959"/>
          </a:xfrm>
          <a:prstGeom prst="rect">
            <a:avLst/>
          </a:prstGeom>
        </p:spPr>
      </p:pic>
      <p:sp>
        <p:nvSpPr>
          <p:cNvPr id="27" name="Rectangle 26">
            <a:extLst>
              <a:ext uri="{FF2B5EF4-FFF2-40B4-BE49-F238E27FC236}">
                <a16:creationId xmlns:a16="http://schemas.microsoft.com/office/drawing/2014/main" id="{29CE51B5-AEB7-4227-8B95-43A20AC303CE}"/>
              </a:ext>
            </a:extLst>
          </p:cNvPr>
          <p:cNvSpPr/>
          <p:nvPr/>
        </p:nvSpPr>
        <p:spPr>
          <a:xfrm>
            <a:off x="278516" y="7247042"/>
            <a:ext cx="6378580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/>
              <a:t>Q9EPC2 Fibroblast Growth Factor 23 FGF23: 7% Coverage (Osteocyte)</a:t>
            </a: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/>
              <a:t>MLGTCLRLLVGVLCTVCSLGTARAYPDTSPLLGSNWGSLTHLYTATARTSYHLQIHRDGHVDGTPHQTIYSALMITSEDAGSVVITGAMTRRFLCMDLHGNIFGSLHFSPENCKFRQWTLENGYDVYLSQKHHYLVSLGRAKR</a:t>
            </a:r>
            <a:r>
              <a:rPr lang="en-US" altLang="en-US" sz="1100" dirty="0">
                <a:solidFill>
                  <a:srgbClr val="00B050"/>
                </a:solidFill>
              </a:rPr>
              <a:t>IFQPGTNPPPFSQFLAR</a:t>
            </a:r>
            <a:r>
              <a:rPr lang="en-US" altLang="en-US" sz="1100" dirty="0"/>
              <a:t>RNEVPLLHFYTVRPRRHTRSAEDPPERDPLNVLKPRPRATPVPVSCSRELPSAEEGGPAASDPLGVLRRGRGDARGGAGGADRCRPFPRFV </a:t>
            </a:r>
          </a:p>
          <a:p>
            <a:endParaRPr lang="en-US" sz="11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B42D730-A411-4F2F-B31A-24DCAE402B82}"/>
              </a:ext>
            </a:extLst>
          </p:cNvPr>
          <p:cNvSpPr txBox="1"/>
          <p:nvPr/>
        </p:nvSpPr>
        <p:spPr>
          <a:xfrm>
            <a:off x="291542" y="6956341"/>
            <a:ext cx="6342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7A76ACB-A80A-4231-93D3-02D37D54ED69}"/>
              </a:ext>
            </a:extLst>
          </p:cNvPr>
          <p:cNvSpPr txBox="1"/>
          <p:nvPr/>
        </p:nvSpPr>
        <p:spPr>
          <a:xfrm>
            <a:off x="5945192" y="6956341"/>
            <a:ext cx="6342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251</a:t>
            </a:r>
          </a:p>
        </p:txBody>
      </p:sp>
    </p:spTree>
    <p:extLst>
      <p:ext uri="{BB962C8B-B14F-4D97-AF65-F5344CB8AC3E}">
        <p14:creationId xmlns:p14="http://schemas.microsoft.com/office/powerpoint/2010/main" val="11372242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9</TotalTime>
  <Words>77</Words>
  <Application>Microsoft Office PowerPoint</Application>
  <PresentationFormat>Letter Paper (8.5x11 in)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cob Rose</dc:creator>
  <cp:lastModifiedBy>Jacob Rose</cp:lastModifiedBy>
  <cp:revision>32</cp:revision>
  <dcterms:created xsi:type="dcterms:W3CDTF">2022-08-02T22:34:55Z</dcterms:created>
  <dcterms:modified xsi:type="dcterms:W3CDTF">2023-05-12T20:25:33Z</dcterms:modified>
</cp:coreProperties>
</file>